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9F910-ADD1-41DF-95AF-EA81FE9EDC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21C18-4D7B-4891-A460-EF88D7FD26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D8E40B-E52A-482E-AEE1-9244B25C17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FC104-B978-4C29-A0F7-4893096170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A8D88-210D-40D5-B06A-8A07FC0AC5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79270-A3F1-4113-BF95-BA819496DD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14318-0C88-4378-B911-FA66078E0D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CBA482-C20C-42BB-8D7D-65468DC4A2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9126A-8343-4C66-9715-D5A894D51D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EA001-29A8-4FAA-A2DA-55DFF7FF83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8F9A1-9944-4F07-BDE1-142CEB8C8D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99FF26-2864-466D-9DAF-8B598AE048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834F95-378A-4DA9-BDF5-81FD00FC911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0" y="219960"/>
            <a:ext cx="621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61800" y="965160"/>
          <a:ext cx="5440680" cy="4300560"/>
        </p:xfrm>
        <a:graphic>
          <a:graphicData uri="http://schemas.openxmlformats.org/drawingml/2006/table">
            <a:tbl>
              <a:tblPr/>
              <a:tblGrid>
                <a:gridCol w="932040"/>
                <a:gridCol w="954000"/>
                <a:gridCol w="906480"/>
                <a:gridCol w="907920"/>
                <a:gridCol w="908280"/>
                <a:gridCol w="831960"/>
              </a:tblGrid>
              <a:tr h="12250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NOVA comparisons of each cell line under  all 4 experiment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          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        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3 ± 11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3± 17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92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       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250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NOVA comparisons of all 5 cell lines under each experimental condi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&lt;0.0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Rectangle 1"/>
          <p:cNvSpPr/>
          <p:nvPr/>
        </p:nvSpPr>
        <p:spPr>
          <a:xfrm>
            <a:off x="0" y="5944320"/>
            <a:ext cx="6218280" cy="193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Summary of short-chain acyl-CoA dehydrogenase deficiency (SCADD), medium-chain acyl-CoA dehydrogenase deficiency (MCADD), carnitine palmitoyltransferase 2 deficiency (CPT2D) and mitochondrial trifunctional protein deficiency (MTPD) patient and control data under the 4 experimental conditions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Comparisons of menadione toxicity by one-way ANOVA after logarithmic transformation to ensure Gaussian distribution  (i) ANOVA comparisons by row (horizontal) are intra-group comparisons. This is to confirm the significant differences between the 4 mean values when each FAO disorder or control cell line is exposed to variable conditions. (ii) ANOVA comparisons by column (vertical) are inter-group comparisons. This is to confirm the significant differences between the 5 mean values from SCADD, MCADD, CPT2/MTPD and control fibroblasts under each experimental condition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48:22Z</dcterms:modified>
  <cp:revision>33</cp:revision>
  <dc:subject/>
  <dc:title>Slide 1</dc:title>
</cp:coreProperties>
</file>